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-3204" y="-7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0D58D-4BF7-4F9B-94F6-1B169E7D68FB}" type="datetimeFigureOut">
              <a:rPr lang="en-CA" smtClean="0"/>
              <a:t>2021-11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1B949-BA5F-402C-AC8A-12CA7570BB8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54991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0D58D-4BF7-4F9B-94F6-1B169E7D68FB}" type="datetimeFigureOut">
              <a:rPr lang="en-CA" smtClean="0"/>
              <a:t>2021-11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1B949-BA5F-402C-AC8A-12CA7570BB8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009321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0D58D-4BF7-4F9B-94F6-1B169E7D68FB}" type="datetimeFigureOut">
              <a:rPr lang="en-CA" smtClean="0"/>
              <a:t>2021-11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1B949-BA5F-402C-AC8A-12CA7570BB8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905174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0D58D-4BF7-4F9B-94F6-1B169E7D68FB}" type="datetimeFigureOut">
              <a:rPr lang="en-CA" smtClean="0"/>
              <a:t>2021-11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1B949-BA5F-402C-AC8A-12CA7570BB8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657487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0D58D-4BF7-4F9B-94F6-1B169E7D68FB}" type="datetimeFigureOut">
              <a:rPr lang="en-CA" smtClean="0"/>
              <a:t>2021-11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1B949-BA5F-402C-AC8A-12CA7570BB8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474739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0D58D-4BF7-4F9B-94F6-1B169E7D68FB}" type="datetimeFigureOut">
              <a:rPr lang="en-CA" smtClean="0"/>
              <a:t>2021-11-2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1B949-BA5F-402C-AC8A-12CA7570BB8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010687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0D58D-4BF7-4F9B-94F6-1B169E7D68FB}" type="datetimeFigureOut">
              <a:rPr lang="en-CA" smtClean="0"/>
              <a:t>2021-11-29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1B949-BA5F-402C-AC8A-12CA7570BB8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005328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0D58D-4BF7-4F9B-94F6-1B169E7D68FB}" type="datetimeFigureOut">
              <a:rPr lang="en-CA" smtClean="0"/>
              <a:t>2021-11-29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1B949-BA5F-402C-AC8A-12CA7570BB8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710981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0D58D-4BF7-4F9B-94F6-1B169E7D68FB}" type="datetimeFigureOut">
              <a:rPr lang="en-CA" smtClean="0"/>
              <a:t>2021-11-29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1B949-BA5F-402C-AC8A-12CA7570BB8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47289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0D58D-4BF7-4F9B-94F6-1B169E7D68FB}" type="datetimeFigureOut">
              <a:rPr lang="en-CA" smtClean="0"/>
              <a:t>2021-11-2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1B949-BA5F-402C-AC8A-12CA7570BB8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572619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0D58D-4BF7-4F9B-94F6-1B169E7D68FB}" type="datetimeFigureOut">
              <a:rPr lang="en-CA" smtClean="0"/>
              <a:t>2021-11-29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81B949-BA5F-402C-AC8A-12CA7570BB8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930813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50D58D-4BF7-4F9B-94F6-1B169E7D68FB}" type="datetimeFigureOut">
              <a:rPr lang="en-CA" smtClean="0"/>
              <a:t>2021-11-29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81B949-BA5F-402C-AC8A-12CA7570BB8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855946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Relationship Id="rId9" Type="http://schemas.openxmlformats.org/officeDocument/2006/relationships/image" Target="../media/image6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microsoft.com/office/2007/relationships/hdphoto" Target="../media/hdphoto4.wdp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microsoft.com/office/2007/relationships/hdphoto" Target="../media/hdphoto3.wdp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5.wdp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microsoft.com/office/2007/relationships/hdphoto" Target="../media/hdphoto6.wdp"/><Relationship Id="rId7" Type="http://schemas.microsoft.com/office/2007/relationships/hdphoto" Target="../media/hdphoto8.wdp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5" Type="http://schemas.microsoft.com/office/2007/relationships/hdphoto" Target="../media/hdphoto7.wdp"/><Relationship Id="rId4" Type="http://schemas.openxmlformats.org/officeDocument/2006/relationships/image" Target="../media/image13.png"/><Relationship Id="rId9" Type="http://schemas.microsoft.com/office/2007/relationships/hdphoto" Target="../media/hdphoto9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357811" y="154631"/>
            <a:ext cx="6329239" cy="8833779"/>
            <a:chOff x="357810" y="95255"/>
            <a:chExt cx="6329239" cy="8833779"/>
          </a:xfrm>
        </p:grpSpPr>
        <p:grpSp>
          <p:nvGrpSpPr>
            <p:cNvPr id="5" name="Group 4"/>
            <p:cNvGrpSpPr/>
            <p:nvPr/>
          </p:nvGrpSpPr>
          <p:grpSpPr>
            <a:xfrm>
              <a:off x="1471292" y="736750"/>
              <a:ext cx="4247509" cy="5972631"/>
              <a:chOff x="1293868" y="755181"/>
              <a:chExt cx="4509212" cy="6303962"/>
            </a:xfrm>
          </p:grpSpPr>
          <p:sp>
            <p:nvSpPr>
              <p:cNvPr id="8" name="TextBox 7"/>
              <p:cNvSpPr txBox="1"/>
              <p:nvPr/>
            </p:nvSpPr>
            <p:spPr>
              <a:xfrm>
                <a:off x="1293868" y="1068779"/>
                <a:ext cx="296883" cy="3573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CA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1293868" y="1966597"/>
                <a:ext cx="296883" cy="3573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1293868" y="4135463"/>
                <a:ext cx="296883" cy="3573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</a:p>
            </p:txBody>
          </p:sp>
          <p:grpSp>
            <p:nvGrpSpPr>
              <p:cNvPr id="11" name="Group 10"/>
              <p:cNvGrpSpPr/>
              <p:nvPr/>
            </p:nvGrpSpPr>
            <p:grpSpPr>
              <a:xfrm>
                <a:off x="1542756" y="755181"/>
                <a:ext cx="4260324" cy="4547921"/>
                <a:chOff x="1542756" y="755181"/>
                <a:chExt cx="4260324" cy="4547921"/>
              </a:xfrm>
            </p:grpSpPr>
            <p:pic>
              <p:nvPicPr>
                <p:cNvPr id="15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2" cstate="print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sharpenSoften amount="49000"/>
                          </a14:imgEffect>
                          <a14:imgEffect>
                            <a14:brightnessContrast bright="14000" contrast="21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483"/>
                <a:stretch/>
              </p:blipFill>
              <p:spPr bwMode="auto">
                <a:xfrm>
                  <a:off x="1542756" y="2135875"/>
                  <a:ext cx="1917887" cy="163773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16" name="Picture 3"/>
                <p:cNvPicPr>
                  <a:picLocks noChangeAspect="1" noChangeArrowheads="1"/>
                </p:cNvPicPr>
                <p:nvPr/>
              </p:nvPicPr>
              <p:blipFill rotWithShape="1">
                <a:blip r:embed="rId4" cstate="print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sharpenSoften amount="49000"/>
                          </a14:imgEffect>
                          <a14:imgEffect>
                            <a14:brightnessContrast bright="49000" contrast="21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086"/>
                <a:stretch/>
              </p:blipFill>
              <p:spPr bwMode="auto">
                <a:xfrm>
                  <a:off x="3908093" y="2135874"/>
                  <a:ext cx="1894987" cy="16377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17" name="Picture 4"/>
                <p:cNvPicPr>
                  <a:picLocks noChangeAspect="1" noChangeArrowheads="1"/>
                </p:cNvPicPr>
                <p:nvPr/>
              </p:nvPicPr>
              <p:blipFill rotWithShape="1"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791"/>
                <a:stretch/>
              </p:blipFill>
              <p:spPr bwMode="auto">
                <a:xfrm>
                  <a:off x="1804459" y="755181"/>
                  <a:ext cx="3736918" cy="127667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18" name="Picture 6"/>
                <p:cNvPicPr>
                  <a:picLocks noChangeAspect="1" noChangeArrowheads="1"/>
                </p:cNvPicPr>
                <p:nvPr/>
              </p:nvPicPr>
              <p:blipFill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804459" y="4149756"/>
                  <a:ext cx="1647836" cy="115334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19" name="Picture 7"/>
                <p:cNvPicPr>
                  <a:picLocks noChangeAspect="1" noChangeArrowheads="1"/>
                </p:cNvPicPr>
                <p:nvPr/>
              </p:nvPicPr>
              <p:blipFill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888295" y="4149756"/>
                  <a:ext cx="1653082" cy="115334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</p:grpSp>
          <p:pic>
            <p:nvPicPr>
              <p:cNvPr id="12" name="Picture 8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880659" y="5439401"/>
                <a:ext cx="3534489" cy="161974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3" name="TextBox 12"/>
              <p:cNvSpPr txBox="1"/>
              <p:nvPr/>
            </p:nvSpPr>
            <p:spPr>
              <a:xfrm>
                <a:off x="1293868" y="5507564"/>
                <a:ext cx="296883" cy="3573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  <a:endParaRPr lang="en-CA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3547889" y="1925141"/>
                <a:ext cx="296883" cy="3573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</p:grpSp>
        <p:sp>
          <p:nvSpPr>
            <p:cNvPr id="6" name="TextBox 5"/>
            <p:cNvSpPr txBox="1"/>
            <p:nvPr/>
          </p:nvSpPr>
          <p:spPr>
            <a:xfrm>
              <a:off x="357810" y="6861801"/>
              <a:ext cx="6329239" cy="20672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100"/>
                </a:lnSpc>
              </a:pPr>
              <a:r>
                <a:rPr lang="en-CA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1</a:t>
              </a:r>
              <a:r>
                <a:rPr lang="en-CA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Confirmation of the correctness of the basic bait constructs to be used inY2H assays.  (</a:t>
              </a:r>
              <a:r>
                <a:rPr lang="en-CA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r>
                <a:rPr lang="en-CA" sz="1000" dirty="0"/>
                <a:t> </a:t>
              </a:r>
              <a:r>
                <a:rPr lang="en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agrams 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f </a:t>
              </a:r>
              <a:r>
                <a:rPr lang="en-CA" sz="10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BS:</a:t>
              </a:r>
              <a:r>
                <a:rPr lang="en-CA" sz="10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tpB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 </a:t>
              </a:r>
              <a:r>
                <a:rPr lang="en-CA" sz="10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BS:groEL</a:t>
              </a:r>
              <a:r>
                <a:rPr lang="en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owing the restriction sites used for cloning (arrowheads). </a:t>
              </a:r>
              <a:r>
                <a:rPr lang="en-CA" sz="10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mp</a:t>
              </a:r>
              <a:r>
                <a:rPr lang="en-CA" sz="1000" baseline="300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s a selection marker that allows growth in media with ampicillin. (</a:t>
              </a:r>
              <a:r>
                <a:rPr lang="en-CA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r>
                <a:rPr lang="en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rose gel (1%) showing </a:t>
              </a:r>
              <a:r>
                <a:rPr lang="en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CR products 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f the predicted size [~1600 base pairs (</a:t>
              </a:r>
              <a:r>
                <a:rPr lang="en-CA" sz="10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p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], </a:t>
              </a:r>
              <a:r>
                <a:rPr lang="en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rresponding to </a:t>
              </a:r>
              <a:r>
                <a:rPr lang="en-CA" sz="10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tpB</a:t>
              </a:r>
              <a:r>
                <a:rPr lang="en-CA" sz="10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 </a:t>
              </a:r>
              <a:r>
                <a:rPr lang="en-CA" sz="10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roEL</a:t>
              </a:r>
              <a:r>
                <a:rPr lang="en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mplified from </a:t>
              </a:r>
              <a:r>
                <a:rPr lang="en-CA" sz="10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</a:t>
              </a:r>
              <a:r>
                <a:rPr lang="en-CA" sz="10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CA" sz="10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neumophila</a:t>
              </a:r>
              <a:r>
                <a:rPr lang="en-CA" sz="10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d </a:t>
              </a:r>
              <a:r>
                <a:rPr lang="en-CA" sz="10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. coli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genomic DNA, respectively. (</a:t>
              </a:r>
              <a:r>
                <a:rPr lang="en-CA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r>
                <a:rPr lang="en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garose gel (1%) 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owing digestion </a:t>
              </a:r>
              <a:r>
                <a:rPr lang="en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ducts 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f </a:t>
              </a:r>
              <a:r>
                <a:rPr lang="en-CA" sz="10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BS:</a:t>
              </a:r>
              <a:r>
                <a:rPr lang="en-CA" sz="10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tpB</a:t>
              </a:r>
              <a:r>
                <a:rPr lang="en-CA" sz="10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r </a:t>
              </a:r>
              <a:r>
                <a:rPr lang="en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BS:</a:t>
              </a:r>
              <a:r>
                <a:rPr lang="en-CA" sz="10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roEL</a:t>
              </a:r>
              <a:r>
                <a:rPr lang="en-CA" sz="10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ith </a:t>
              </a:r>
              <a:r>
                <a:rPr lang="en-CA" sz="10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co</a:t>
              </a:r>
              <a:r>
                <a:rPr lang="en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I</a:t>
              </a:r>
              <a:r>
                <a:rPr lang="en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/</a:t>
              </a:r>
              <a:r>
                <a:rPr lang="en-CA" sz="10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am</a:t>
              </a:r>
              <a:r>
                <a:rPr lang="en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I</a:t>
              </a:r>
              <a:r>
                <a:rPr lang="en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r </a:t>
              </a:r>
              <a:r>
                <a:rPr lang="en-CA" sz="10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co</a:t>
              </a:r>
              <a:r>
                <a:rPr lang="en-CA" sz="10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I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/</a:t>
              </a:r>
              <a:r>
                <a:rPr lang="en-CA" sz="10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al</a:t>
              </a:r>
              <a:r>
                <a:rPr lang="en-CA" sz="10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respectively. Two restriction fragments of the predicted size </a:t>
              </a:r>
              <a:r>
                <a:rPr lang="en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~3000 </a:t>
              </a:r>
              <a:r>
                <a:rPr lang="en-CA" sz="10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p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d </a:t>
              </a:r>
              <a:r>
                <a:rPr lang="en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~1600 </a:t>
              </a:r>
              <a:r>
                <a:rPr lang="en-CA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p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are observed on each lane, corresponding to the linearized </a:t>
              </a:r>
              <a:r>
                <a:rPr lang="en-CA" sz="10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BS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vector (top bands), and the chaperonin genes (bottom). (</a:t>
              </a:r>
              <a:r>
                <a:rPr lang="en-CA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Diagrams of </a:t>
              </a:r>
              <a:r>
                <a:rPr lang="en-CA" sz="10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GBK:</a:t>
              </a:r>
              <a:r>
                <a:rPr lang="en-CA" sz="10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tpB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 </a:t>
              </a:r>
              <a:r>
                <a:rPr lang="en-CA" sz="10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GBK:</a:t>
              </a:r>
              <a:r>
                <a:rPr lang="en-CA" sz="10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roEL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howing their main components and the </a:t>
              </a:r>
              <a:r>
                <a:rPr lang="en-CA" sz="10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co</a:t>
              </a:r>
              <a:r>
                <a:rPr lang="en-CA" sz="10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I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</a:t>
              </a:r>
              <a:r>
                <a:rPr lang="en-CA" sz="10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m</a:t>
              </a:r>
              <a:r>
                <a:rPr lang="en-CA" sz="10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I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d </a:t>
              </a:r>
              <a:r>
                <a:rPr lang="en-CA" sz="10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al</a:t>
              </a:r>
              <a:r>
                <a:rPr lang="en-CA" sz="10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restriction sites (arrowheads). </a:t>
              </a:r>
              <a:r>
                <a:rPr lang="en-CA" sz="10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an</a:t>
              </a:r>
              <a:r>
                <a:rPr lang="en-CA" sz="1000" baseline="300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d TRP1 are selection markers that allow growth in media with kanamycin or without tryptophan, respectively. The </a:t>
              </a:r>
              <a:r>
                <a:rPr lang="en-CA" sz="10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tpB</a:t>
              </a:r>
              <a:r>
                <a:rPr lang="en-CA" sz="10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 </a:t>
              </a:r>
              <a:r>
                <a:rPr lang="en-CA" sz="10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roEL</a:t>
              </a:r>
              <a:r>
                <a:rPr lang="en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es were </a:t>
              </a:r>
              <a:r>
                <a:rPr lang="en-CA" sz="10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bcloned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n translational frame with Gal4BD/c-</a:t>
              </a:r>
              <a:r>
                <a:rPr lang="en-CA" sz="10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yc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so that the chaperonins are</a:t>
              </a:r>
              <a:r>
                <a:rPr lang="en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expressed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s fusion proteins, as confirmed by immunoblotting. (</a:t>
              </a:r>
              <a:r>
                <a:rPr lang="en-CA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Immunoblot membranes from total proteins of </a:t>
              </a:r>
              <a:r>
                <a:rPr lang="en-CA" sz="10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.coli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DH5</a:t>
              </a:r>
              <a:r>
                <a:rPr lang="el-G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transformed with the plasmids indicated on top of the panel.  </a:t>
              </a:r>
              <a:r>
                <a:rPr lang="en-CA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mbranes were immuno-stained with a c-</a:t>
              </a:r>
              <a:r>
                <a:rPr lang="en-CA" sz="10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yc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specific monoclonal antibody (Anti-c-</a:t>
              </a:r>
              <a:r>
                <a:rPr lang="en-CA" sz="10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yc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, or a </a:t>
              </a:r>
              <a:r>
                <a:rPr lang="en-CA" sz="10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tpB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specific polyclonal antibody (</a:t>
              </a:r>
              <a:r>
                <a:rPr lang="en-CA" sz="10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nti-HtpB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that weakly </a:t>
              </a:r>
              <a:r>
                <a:rPr lang="en-CA" sz="10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rossreacts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with </a:t>
              </a:r>
              <a:r>
                <a:rPr lang="en-CA" sz="10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roEL</a:t>
              </a:r>
              <a:r>
                <a:rPr lang="en-CA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but not with its fusion protein.</a:t>
              </a:r>
              <a:r>
                <a:rPr lang="en-CA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CA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774283" y="95255"/>
              <a:ext cx="1496291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dirty="0" smtClean="0"/>
                <a:t>Supplemental</a:t>
              </a:r>
            </a:p>
            <a:p>
              <a:pPr algn="ctr"/>
              <a:r>
                <a:rPr lang="en-CA" dirty="0" smtClean="0"/>
                <a:t>Figure S1</a:t>
              </a:r>
              <a:endParaRPr lang="en-CA" dirty="0"/>
            </a:p>
          </p:txBody>
        </p:sp>
      </p:grpSp>
    </p:spTree>
    <p:extLst>
      <p:ext uri="{BB962C8B-B14F-4D97-AF65-F5344CB8AC3E}">
        <p14:creationId xmlns:p14="http://schemas.microsoft.com/office/powerpoint/2010/main" val="40274142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742212" y="701895"/>
            <a:ext cx="5688280" cy="7385981"/>
            <a:chOff x="742212" y="701895"/>
            <a:chExt cx="5688280" cy="7385981"/>
          </a:xfrm>
        </p:grpSpPr>
        <p:grpSp>
          <p:nvGrpSpPr>
            <p:cNvPr id="3" name="Group 2"/>
            <p:cNvGrpSpPr/>
            <p:nvPr/>
          </p:nvGrpSpPr>
          <p:grpSpPr>
            <a:xfrm>
              <a:off x="2005360" y="1324850"/>
              <a:ext cx="3181053" cy="4807504"/>
              <a:chOff x="1625360" y="1657350"/>
              <a:chExt cx="3181053" cy="4807504"/>
            </a:xfrm>
          </p:grpSpPr>
          <p:pic>
            <p:nvPicPr>
              <p:cNvPr id="6" name="Picture 2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638094" y="1657350"/>
                <a:ext cx="1098148" cy="23764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7" name="Picture 3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harpenSoften amount="25000"/>
                        </a14:imgEffect>
                        <a14:imgEffect>
                          <a14:saturation sat="66000"/>
                        </a14:imgEffect>
                        <a14:imgEffect>
                          <a14:brightnessContrast bright="-3000" contrast="2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752096" y="1964743"/>
                <a:ext cx="2038336" cy="205956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8" name="Picture 4"/>
              <p:cNvPicPr>
                <a:picLocks noChangeAspect="1" noChangeArrowheads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625360" y="4123152"/>
                <a:ext cx="1130938" cy="229563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9" name="Picture 5"/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sharpenSoften amount="25000"/>
                        </a14:imgEffect>
                        <a14:imgEffect>
                          <a14:saturation sat="66000"/>
                        </a14:imgEffect>
                        <a14:imgEffect>
                          <a14:brightnessContrast bright="-7000" contrast="21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767909" y="4096541"/>
                <a:ext cx="2038504" cy="2368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4" name="TextBox 3"/>
            <p:cNvSpPr txBox="1"/>
            <p:nvPr/>
          </p:nvSpPr>
          <p:spPr>
            <a:xfrm>
              <a:off x="2802580" y="701895"/>
              <a:ext cx="1567543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dirty="0" smtClean="0"/>
                <a:t>Supplemental</a:t>
              </a:r>
            </a:p>
            <a:p>
              <a:pPr algn="ctr"/>
              <a:r>
                <a:rPr lang="en-CA" dirty="0" smtClean="0"/>
                <a:t>Figure </a:t>
              </a:r>
              <a:r>
                <a:rPr lang="en-CA" dirty="0"/>
                <a:t>S</a:t>
              </a:r>
              <a:r>
                <a:rPr lang="en-CA" dirty="0" smtClean="0"/>
                <a:t>2</a:t>
              </a:r>
              <a:endParaRPr lang="en-CA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742212" y="6472049"/>
              <a:ext cx="5688280" cy="16158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2</a:t>
              </a:r>
              <a:r>
                <a:rPr lang="en-CA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Confirmation that </a:t>
              </a:r>
              <a:r>
                <a:rPr lang="en-CA" sz="11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tpB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ut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t </a:t>
              </a:r>
              <a:r>
                <a:rPr lang="en-CA" sz="11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roEL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sistently binds hECM29 in Y2H Plate assays.  Plasmid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GAD:</a:t>
              </a:r>
              <a:r>
                <a:rPr lang="en-CA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ECM29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scued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rom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 positive clone of a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ibrary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creening was co-transformed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nto </a:t>
              </a:r>
              <a:r>
                <a:rPr lang="en-CA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. cerevisiae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with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bait plasmids </a:t>
              </a:r>
              <a:r>
                <a:rPr lang="en-CA" sz="11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GBK:</a:t>
              </a:r>
              <a:r>
                <a:rPr lang="en-CA" sz="11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tpB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r </a:t>
              </a:r>
              <a:r>
                <a:rPr lang="en-CA" sz="11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GBK:</a:t>
              </a:r>
              <a:r>
                <a:rPr lang="en-CA" sz="11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roEL</a:t>
              </a:r>
              <a:r>
                <a:rPr lang="en-CA" sz="11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,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r with the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mpty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it plasmid (pGBKT7).  Co-</a:t>
              </a:r>
              <a:r>
                <a:rPr lang="en-CA" sz="11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ansformants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ere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lected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 DDO plates and then grown overnight in DDO broth. Then, 10-μl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rops of undiluted (10</a:t>
              </a:r>
              <a:r>
                <a:rPr lang="en-CA" sz="11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r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en-fold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erially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luted (10</a:t>
              </a:r>
              <a:r>
                <a:rPr lang="en-CA" sz="11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1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10</a:t>
              </a:r>
              <a:r>
                <a:rPr lang="en-CA" sz="11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2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10</a:t>
              </a:r>
              <a:r>
                <a:rPr lang="en-CA" sz="11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3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roth culture were spotted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nto DDO/X/A plates (</a:t>
              </a:r>
              <a:r>
                <a:rPr lang="en-CA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and QDO/X/A plates (</a:t>
              </a:r>
              <a:r>
                <a:rPr lang="en-CA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. Pictures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own were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aken after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 days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f incubation at 30°C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 Assays in DDO/X/A could give weak false positives (presence of growth and blue colonies in the spots of undiluted culture, as shown in panel A), but assays is QDO/X/A were consistently unequivocal.</a:t>
              </a:r>
              <a:endParaRPr lang="en-CA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709161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841602" y="701895"/>
            <a:ext cx="5624477" cy="7326822"/>
            <a:chOff x="841602" y="701895"/>
            <a:chExt cx="5624477" cy="7326822"/>
          </a:xfrm>
        </p:grpSpPr>
        <p:grpSp>
          <p:nvGrpSpPr>
            <p:cNvPr id="3" name="Group 2"/>
            <p:cNvGrpSpPr/>
            <p:nvPr/>
          </p:nvGrpSpPr>
          <p:grpSpPr>
            <a:xfrm>
              <a:off x="841602" y="1323887"/>
              <a:ext cx="5624477" cy="4168091"/>
              <a:chOff x="841602" y="2266367"/>
              <a:chExt cx="5624477" cy="4168091"/>
            </a:xfrm>
          </p:grpSpPr>
          <p:pic>
            <p:nvPicPr>
              <p:cNvPr id="6" name="Picture 2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sharpenSoften amount="25000"/>
                        </a14:imgEffect>
                        <a14:imgEffect>
                          <a14:saturation sat="200000"/>
                        </a14:imgEffect>
                        <a14:imgEffect>
                          <a14:brightnessContrast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841602" y="2266367"/>
                <a:ext cx="5624477" cy="41007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7" name="Rectangle 6"/>
              <p:cNvSpPr/>
              <p:nvPr/>
            </p:nvSpPr>
            <p:spPr>
              <a:xfrm>
                <a:off x="4347607" y="6333481"/>
                <a:ext cx="1166842" cy="10097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/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4313950" y="6185355"/>
                <a:ext cx="47963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800" dirty="0" smtClean="0">
                    <a:latin typeface="HoloLens MDL2 Assets" panose="050A0102010101010101" pitchFamily="18" charset="0"/>
                  </a:rPr>
                  <a:t>readings</a:t>
                </a:r>
                <a:endParaRPr lang="en-CA" sz="800" dirty="0">
                  <a:latin typeface="HoloLens MDL2 Assets" panose="050A0102010101010101" pitchFamily="18" charset="0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5117087" y="6192096"/>
                <a:ext cx="47963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800" dirty="0" smtClean="0">
                    <a:latin typeface="HoloLens MDL2 Assets" panose="050A0102010101010101" pitchFamily="18" charset="0"/>
                  </a:rPr>
                  <a:t>readings</a:t>
                </a:r>
                <a:endParaRPr lang="en-CA" sz="800" dirty="0">
                  <a:latin typeface="HoloLens MDL2 Assets" panose="050A0102010101010101" pitchFamily="18" charset="0"/>
                </a:endParaRPr>
              </a:p>
            </p:txBody>
          </p:sp>
        </p:grpSp>
        <p:sp>
          <p:nvSpPr>
            <p:cNvPr id="4" name="TextBox 3"/>
            <p:cNvSpPr txBox="1"/>
            <p:nvPr/>
          </p:nvSpPr>
          <p:spPr>
            <a:xfrm>
              <a:off x="2861371" y="701895"/>
              <a:ext cx="1584938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dirty="0" smtClean="0"/>
                <a:t>Supplemental</a:t>
              </a:r>
            </a:p>
            <a:p>
              <a:pPr algn="ctr"/>
              <a:r>
                <a:rPr lang="en-CA" dirty="0" smtClean="0"/>
                <a:t>Figure S3</a:t>
              </a:r>
              <a:endParaRPr lang="en-CA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841602" y="5735782"/>
              <a:ext cx="5624477" cy="22929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3</a:t>
              </a:r>
              <a:r>
                <a:rPr lang="en-CA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Schematic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resentations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f the DNA sequencing runs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one to confirm the correctness of bait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structs.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equencing of </a:t>
              </a:r>
              <a:r>
                <a:rPr lang="en-CA" sz="11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tpB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d </a:t>
              </a:r>
              <a:r>
                <a:rPr lang="en-CA" sz="11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roEL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es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top green lines of the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nels indicating the gene’s nucleotide span) is shown on panels </a:t>
              </a:r>
              <a:r>
                <a:rPr lang="en-CA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 </a:t>
              </a:r>
              <a:r>
                <a:rPr lang="en-CA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respectively. All sequencing was done using </a:t>
              </a:r>
              <a:r>
                <a:rPr lang="en-CA" sz="11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BS:</a:t>
              </a:r>
              <a:r>
                <a:rPr lang="en-CA" sz="11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tpB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r </a:t>
              </a:r>
              <a:r>
                <a:rPr lang="en-CA" sz="11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BS:</a:t>
              </a:r>
              <a:r>
                <a:rPr lang="en-CA" sz="11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roEL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onstructs as template, including both the wild type genes, as well as the genes carrying single site- or multiple site-directed mutations.  The various primers used are indicated above the corresponding lines that represent the sequencing runs, along with the run’s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ucleotide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pan (i.e. </a:t>
              </a:r>
              <a:r>
                <a:rPr lang="en-CA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ig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ength).  Green solid lines correspond to forward readings (in the same direction as gene transcription) and red dotted lines indicate reverse readings.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</a:t>
              </a:r>
              <a:r>
                <a:rPr lang="en-CA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equencher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oftware was used to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ssemble the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adings obtained from each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imer, either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gainst the </a:t>
              </a:r>
              <a:r>
                <a:rPr lang="en-CA" sz="11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tpB</a:t>
              </a:r>
              <a:r>
                <a:rPr lang="en-CA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I:AE017354.1:740047-741699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r the </a:t>
              </a:r>
              <a:r>
                <a:rPr lang="en-CA" sz="11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roEL</a:t>
              </a:r>
              <a:r>
                <a:rPr lang="en-CA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GI:45686197)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uence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trieved from the NCBI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tabase. The bottom bar of each panel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resents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coverage for each section of the corresponding reference gene.  The coverage code is given at the bottom of the figure, and applies to both panels.</a:t>
              </a:r>
              <a:endParaRPr lang="en-CA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81191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565151" y="701894"/>
            <a:ext cx="5956300" cy="7819250"/>
            <a:chOff x="565150" y="701894"/>
            <a:chExt cx="5956300" cy="7819250"/>
          </a:xfrm>
        </p:grpSpPr>
        <p:sp>
          <p:nvSpPr>
            <p:cNvPr id="3" name="TextBox 2"/>
            <p:cNvSpPr txBox="1"/>
            <p:nvPr/>
          </p:nvSpPr>
          <p:spPr>
            <a:xfrm>
              <a:off x="2799482" y="701894"/>
              <a:ext cx="1532793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dirty="0" smtClean="0"/>
                <a:t>Supplemental</a:t>
              </a:r>
            </a:p>
            <a:p>
              <a:pPr algn="ctr"/>
              <a:r>
                <a:rPr lang="en-CA" dirty="0" smtClean="0"/>
                <a:t>Figure S4</a:t>
              </a:r>
              <a:endParaRPr lang="en-CA" dirty="0"/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565150" y="5689600"/>
              <a:ext cx="5956300" cy="28315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4</a:t>
              </a:r>
              <a:r>
                <a:rPr lang="en-CA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ome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te-directed mutations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 </a:t>
              </a:r>
              <a:r>
                <a:rPr lang="en-CA" sz="11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tpB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led to changes in restriction sites.  (</a:t>
              </a:r>
              <a:r>
                <a:rPr lang="en-CA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Diagram depicting the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ss of a </a:t>
              </a:r>
              <a:r>
                <a:rPr lang="en-CA" sz="11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at</a:t>
              </a:r>
              <a:r>
                <a:rPr lang="en-CA" sz="11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restriction site (red circles)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 </a:t>
              </a:r>
              <a:r>
                <a:rPr lang="en-CA" sz="11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tpB</a:t>
              </a:r>
              <a:r>
                <a:rPr lang="en-CA" sz="11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lue bar) by the M212A mutation, and how PCR amplification with primers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tpB-419_F and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tpB-1200_R (represented by the red arrows and dotted lines), followed by digestion with </a:t>
              </a:r>
              <a:r>
                <a:rPr lang="en-CA" sz="11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at</a:t>
              </a:r>
              <a:r>
                <a:rPr lang="en-CA" sz="11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results in the creation of restriction fragments of different sizes in wild type or mutant </a:t>
              </a:r>
              <a:r>
                <a:rPr lang="en-CA" sz="11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tpB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 Size is given in base pairs at the top of each fragment. (</a:t>
              </a:r>
              <a:r>
                <a:rPr lang="en-CA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Agarose gel (2%) showing the </a:t>
              </a:r>
              <a:r>
                <a:rPr lang="en-CA" sz="11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at</a:t>
              </a:r>
              <a:r>
                <a:rPr lang="en-CA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gestion products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rom either </a:t>
              </a:r>
              <a:r>
                <a:rPr lang="en-CA" sz="11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tpB</a:t>
              </a:r>
              <a:r>
                <a:rPr lang="en-CA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212A or WT </a:t>
              </a:r>
              <a:r>
                <a:rPr lang="en-CA" sz="11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tpB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according to their predicted sizes, thereby</a:t>
              </a:r>
              <a:r>
                <a:rPr lang="en-CA" sz="11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firming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correctness of the site-directed mutation. DNA fragment sizes are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dicated on the left side of the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nel. The first lane in the gel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 a 100 </a:t>
              </a:r>
              <a:r>
                <a:rPr lang="en-CA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p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ladder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 (</a:t>
              </a:r>
              <a:r>
                <a:rPr lang="en-CA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Diagram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picting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reation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f a </a:t>
              </a:r>
              <a:r>
                <a:rPr lang="en-CA" sz="11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st</a:t>
              </a:r>
              <a:r>
                <a:rPr lang="en-CA" sz="11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striction site (red circles) in </a:t>
              </a:r>
              <a:r>
                <a:rPr lang="en-CA" sz="11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tpB</a:t>
              </a:r>
              <a:r>
                <a:rPr lang="en-CA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lue bar) by the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507A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utation, and how PCR amplification with primers </a:t>
              </a:r>
              <a:r>
                <a:rPr lang="en-CA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coRI-HtpB_F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d </a:t>
              </a:r>
              <a:r>
                <a:rPr lang="en-CA" sz="11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mHI-HtpB_R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represented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y the red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rrows and dotted lines),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llowed by digestion with </a:t>
              </a:r>
              <a:r>
                <a:rPr lang="en-CA" sz="11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st</a:t>
              </a:r>
              <a:r>
                <a:rPr lang="en-CA" sz="11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results in the creation of restriction fragments of different sizes in wild type or mutant </a:t>
              </a:r>
              <a:r>
                <a:rPr lang="en-CA" sz="11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tpB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 Size is given in base pairs at the top of each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ragment. (</a:t>
              </a:r>
              <a:r>
                <a:rPr lang="en-CA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garose gel (2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) showing the PCR amplicons (– </a:t>
              </a:r>
              <a:r>
                <a:rPr lang="en-CA" sz="11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st</a:t>
              </a:r>
              <a:r>
                <a:rPr lang="en-CA" sz="11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lanes) and the </a:t>
              </a:r>
              <a:r>
                <a:rPr lang="en-CA" sz="11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st</a:t>
              </a:r>
              <a:r>
                <a:rPr lang="en-CA" sz="11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gestion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ducts (+ </a:t>
              </a:r>
              <a:r>
                <a:rPr lang="en-CA" sz="11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st</a:t>
              </a:r>
              <a:r>
                <a:rPr lang="en-CA" sz="11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lanes) from either </a:t>
              </a:r>
              <a:r>
                <a:rPr lang="en-CA" sz="11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tpB</a:t>
              </a:r>
              <a:r>
                <a:rPr lang="en-CA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507A or WT </a:t>
              </a:r>
              <a:r>
                <a:rPr lang="en-CA" sz="11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tpB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cording to their predicted sizes, thereby</a:t>
              </a:r>
              <a:r>
                <a:rPr lang="en-CA" sz="11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firming the correctness of the </a:t>
              </a:r>
              <a:r>
                <a:rPr lang="en-CA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te-directed 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utation. DNA fragment sizes are indicated on the left side of the panel. The first lane in the gel is a 100 </a:t>
              </a:r>
              <a:r>
                <a:rPr lang="en-CA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p</a:t>
              </a:r>
              <a:r>
                <a:rPr lang="en-CA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ladder.</a:t>
              </a:r>
            </a:p>
          </p:txBody>
        </p:sp>
        <p:grpSp>
          <p:nvGrpSpPr>
            <p:cNvPr id="5" name="Group 4"/>
            <p:cNvGrpSpPr/>
            <p:nvPr/>
          </p:nvGrpSpPr>
          <p:grpSpPr>
            <a:xfrm>
              <a:off x="909082" y="1429403"/>
              <a:ext cx="5380719" cy="4193364"/>
              <a:chOff x="909082" y="1429403"/>
              <a:chExt cx="5380719" cy="4193364"/>
            </a:xfrm>
          </p:grpSpPr>
          <p:grpSp>
            <p:nvGrpSpPr>
              <p:cNvPr id="8" name="Group 7"/>
              <p:cNvGrpSpPr/>
              <p:nvPr/>
            </p:nvGrpSpPr>
            <p:grpSpPr>
              <a:xfrm>
                <a:off x="909082" y="1429403"/>
                <a:ext cx="5380719" cy="4193364"/>
                <a:chOff x="909082" y="1797703"/>
                <a:chExt cx="5380719" cy="4193364"/>
              </a:xfrm>
            </p:grpSpPr>
            <p:grpSp>
              <p:nvGrpSpPr>
                <p:cNvPr id="10" name="Group 9"/>
                <p:cNvGrpSpPr/>
                <p:nvPr/>
              </p:nvGrpSpPr>
              <p:grpSpPr>
                <a:xfrm>
                  <a:off x="921978" y="3861542"/>
                  <a:ext cx="5339274" cy="2129525"/>
                  <a:chOff x="993228" y="2111694"/>
                  <a:chExt cx="5339274" cy="2129525"/>
                </a:xfrm>
              </p:grpSpPr>
              <p:pic>
                <p:nvPicPr>
                  <p:cNvPr id="14" name="Picture 3"/>
                  <p:cNvPicPr>
                    <a:picLocks noChangeAspect="1" noChangeArrowheads="1"/>
                  </p:cNvPicPr>
                  <p:nvPr/>
                </p:nvPicPr>
                <p:blipFill>
                  <a:blip r:embed="rId2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3">
                            <a14:imgEffect>
                              <a14:sharpenSoften amount="42000"/>
                            </a14:imgEffect>
                            <a14:imgEffect>
                              <a14:colorTemperature colorTemp="7200"/>
                            </a14:imgEffect>
                            <a14:imgEffect>
                              <a14:brightnessContrast bright="3000" contrast="21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993228" y="2111694"/>
                    <a:ext cx="5339274" cy="196911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15" name="Picture 2"/>
                  <p:cNvPicPr>
                    <a:picLocks noChangeAspect="1" noChangeArrowheads="1"/>
                  </p:cNvPicPr>
                  <p:nvPr/>
                </p:nvPicPr>
                <p:blipFill>
                  <a:blip r:embed="rId4" cstate="print">
                    <a:grayscl/>
                    <a:extLst>
                      <a:ext uri="{BEBA8EAE-BF5A-486C-A8C5-ECC9F3942E4B}">
                        <a14:imgProps xmlns:a14="http://schemas.microsoft.com/office/drawing/2010/main">
                          <a14:imgLayer r:embed="rId5">
                            <a14:imgEffect>
                              <a14:sharpenSoften amount="49000"/>
                            </a14:imgEffect>
                            <a14:imgEffect>
                              <a14:brightnessContrast bright="-14000" contrast="-14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4348962" y="2455815"/>
                    <a:ext cx="1983539" cy="144383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sp>
                <p:nvSpPr>
                  <p:cNvPr id="16" name="TextBox 15"/>
                  <p:cNvSpPr txBox="1"/>
                  <p:nvPr/>
                </p:nvSpPr>
                <p:spPr>
                  <a:xfrm>
                    <a:off x="5298142" y="3994998"/>
                    <a:ext cx="393632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CA" sz="1000" b="1" i="1" dirty="0" err="1" smtClean="0"/>
                      <a:t>Pst</a:t>
                    </a:r>
                    <a:r>
                      <a:rPr lang="en-CA" sz="1000" b="1" dirty="0" err="1" smtClean="0"/>
                      <a:t>I</a:t>
                    </a:r>
                    <a:endParaRPr lang="en-CA" sz="1000" b="1" dirty="0"/>
                  </a:p>
                </p:txBody>
              </p:sp>
              <p:sp>
                <p:nvSpPr>
                  <p:cNvPr id="17" name="Rectangle 16"/>
                  <p:cNvSpPr/>
                  <p:nvPr/>
                </p:nvSpPr>
                <p:spPr>
                  <a:xfrm>
                    <a:off x="4444864" y="3950990"/>
                    <a:ext cx="232268" cy="129814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CA"/>
                  </a:p>
                </p:txBody>
              </p:sp>
            </p:grpSp>
            <p:grpSp>
              <p:nvGrpSpPr>
                <p:cNvPr id="11" name="Group 10"/>
                <p:cNvGrpSpPr/>
                <p:nvPr/>
              </p:nvGrpSpPr>
              <p:grpSpPr>
                <a:xfrm>
                  <a:off x="909082" y="1797703"/>
                  <a:ext cx="5380719" cy="1999793"/>
                  <a:chOff x="909082" y="1797703"/>
                  <a:chExt cx="5380719" cy="1999793"/>
                </a:xfrm>
              </p:grpSpPr>
              <p:pic>
                <p:nvPicPr>
                  <p:cNvPr id="12" name="Picture 5"/>
                  <p:cNvPicPr>
                    <a:picLocks noChangeAspect="1" noChangeArrowheads="1"/>
                  </p:cNvPicPr>
                  <p:nvPr/>
                </p:nvPicPr>
                <p:blipFill>
                  <a:blip r:embed="rId6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7">
                            <a14:imgEffect>
                              <a14:sharpenSoften amount="25000"/>
                            </a14:imgEffect>
                            <a14:imgEffect>
                              <a14:colorTemperature colorTemp="7200"/>
                            </a14:imgEffect>
                            <a14:imgEffect>
                              <a14:brightnessContrast contras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909082" y="1797703"/>
                    <a:ext cx="5380719" cy="199979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13" name="Picture 4"/>
                  <p:cNvPicPr>
                    <a:picLocks noChangeAspect="1" noChangeArrowheads="1"/>
                  </p:cNvPicPr>
                  <p:nvPr/>
                </p:nvPicPr>
                <p:blipFill>
                  <a:blip r:embed="rId8" cstate="print">
                    <a:grayscl/>
                    <a:extLst>
                      <a:ext uri="{BEBA8EAE-BF5A-486C-A8C5-ECC9F3942E4B}">
                        <a14:imgProps xmlns:a14="http://schemas.microsoft.com/office/drawing/2010/main">
                          <a14:imgLayer r:embed="rId9">
                            <a14:imgEffect>
                              <a14:sharpenSoften amount="-49000"/>
                            </a14:imgEffect>
                            <a14:imgEffect>
                              <a14:saturation sat="66000"/>
                            </a14:imgEffect>
                            <a14:imgEffect>
                              <a14:brightnessContrast bright="-14000" contrast="-21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4332275" y="2137834"/>
                    <a:ext cx="1928976" cy="162812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</p:grpSp>
          </p:grpSp>
          <p:sp>
            <p:nvSpPr>
              <p:cNvPr id="9" name="TextBox 8"/>
              <p:cNvSpPr txBox="1"/>
              <p:nvPr/>
            </p:nvSpPr>
            <p:spPr>
              <a:xfrm>
                <a:off x="2254250" y="1632603"/>
                <a:ext cx="4699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800" b="1" dirty="0" smtClean="0"/>
                  <a:t>~1600</a:t>
                </a:r>
                <a:endParaRPr lang="en-CA" sz="800" b="1" dirty="0"/>
              </a:p>
            </p:txBody>
          </p:sp>
        </p:grpSp>
        <p:sp>
          <p:nvSpPr>
            <p:cNvPr id="6" name="TextBox 5"/>
            <p:cNvSpPr txBox="1"/>
            <p:nvPr/>
          </p:nvSpPr>
          <p:spPr>
            <a:xfrm>
              <a:off x="882650" y="3391096"/>
              <a:ext cx="184150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400" b="1" dirty="0" smtClean="0"/>
                <a:t>C</a:t>
              </a:r>
              <a:endParaRPr lang="en-CA" sz="1400" b="1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873500" y="3391096"/>
              <a:ext cx="184150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400" b="1" dirty="0"/>
                <a:t>D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8013485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965</Words>
  <Application>Microsoft Office PowerPoint</Application>
  <PresentationFormat>Letter Paper (8.5x11 in)</PresentationFormat>
  <Paragraphs>23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fael Garduno</dc:creator>
  <cp:lastModifiedBy>Rafael Garduno</cp:lastModifiedBy>
  <cp:revision>1</cp:revision>
  <dcterms:created xsi:type="dcterms:W3CDTF">2021-11-30T03:20:08Z</dcterms:created>
  <dcterms:modified xsi:type="dcterms:W3CDTF">2021-11-30T03:28:56Z</dcterms:modified>
</cp:coreProperties>
</file>